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4" name="Google Shape;153;p19"/>
          <p:cNvPicPr/>
          <p:nvPr/>
        </p:nvPicPr>
        <p:blipFill>
          <a:blip r:embed="rId2">
            <a:alphaModFix/>
          </a:blip>
          <a:stretch/>
        </p:blipFill>
        <p:spPr bwMode="auto">
          <a:xfrm>
            <a:off x="3309716" y="239348"/>
            <a:ext cx="5495070" cy="462791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154;p19"/>
          <p:cNvSpPr/>
          <p:nvPr/>
        </p:nvSpPr>
        <p:spPr bwMode="auto">
          <a:xfrm>
            <a:off x="2060427" y="5002767"/>
            <a:ext cx="8617635" cy="10058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just">
              <a:defRPr/>
            </a:pPr>
            <a:r>
              <a:rPr sz="1500" b="1" i="0" u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Supplementary Figure S9. </a:t>
            </a:r>
            <a:r>
              <a:rPr sz="1500" b="0" i="1" u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Short-term spatial memory assessment in WT (n = 20) and cKO (n = 18) mice in Y-maze</a:t>
            </a:r>
            <a:r>
              <a:rPr sz="1500" b="0" i="0" u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. Total distance (a) and average velocity (b) are shown for WT and cKO mice at 4  (A) and 9 (B) months of age. Results are shown as mean ± SEM. No statistical differences were observed between WT and cKO mice.</a:t>
            </a:r>
            <a:endParaRPr/>
          </a:p>
        </p:txBody>
      </p:sp>
    </p:spTree>
    <p:extLst>
      <p:ext uri="{BB962C8B-B14F-4D97-AF65-F5344CB8AC3E}">
        <p14:creationId xmlns:p14="http://schemas.microsoft.com/office/powerpoint/2010/main" val="12042372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w="http://schemas.openxmlformats.org/wordprocessingml/2006/main" xmlns:m="http://schemas.openxmlformats.org/officeDocument/2006/math" xmlns="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7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7</cp:revision>
  <dcterms:created xsi:type="dcterms:W3CDTF">2022-01-28T21:57:26Z</dcterms:created>
  <dcterms:modified xsi:type="dcterms:W3CDTF">2022-01-28T22:01:26Z</dcterms:modified>
</cp:coreProperties>
</file>